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11" userDrawn="1">
          <p15:clr>
            <a:srgbClr val="A4A3A4"/>
          </p15:clr>
        </p15:guide>
        <p15:guide id="2" pos="64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>
        <p:scale>
          <a:sx n="78" d="100"/>
          <a:sy n="78" d="100"/>
        </p:scale>
        <p:origin x="77" y="206"/>
      </p:cViewPr>
      <p:guideLst>
        <p:guide orient="horz" pos="1911"/>
        <p:guide pos="6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26C31C-729F-4C02-8015-D3A381A0FFA3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F1D78E-4B3D-4ECC-97D4-272AE6F44C9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735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0868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1311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3981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5850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6883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1955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9112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6446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0216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44631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76080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DDB8B-B55F-439E-A278-8B8532129880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07A2D-FB54-4AAB-858D-14C8F9194C8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051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" y="0"/>
            <a:ext cx="6251640" cy="526136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77317" y="5280709"/>
            <a:ext cx="57759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600" dirty="0" smtClean="0"/>
              <a:t>Supplemental Figure 1: Ct value comparisons between the Xpert Xpress SARS-CoV-2/Flu/RSV Combination Test and SARS-CoV-2/Flu/RSV PLUS Assay. Results shown for RSV broken down into RSV A and RSV B subtypes, or untyped. </a:t>
            </a:r>
            <a:endParaRPr lang="en-CA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3117532" y="1657349"/>
            <a:ext cx="1200150" cy="33855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CA" sz="1600" b="1" dirty="0" smtClean="0">
                <a:solidFill>
                  <a:schemeClr val="bg2">
                    <a:lumMod val="25000"/>
                  </a:schemeClr>
                </a:solidFill>
              </a:rPr>
              <a:t>R</a:t>
            </a:r>
            <a:r>
              <a:rPr lang="en-CA" sz="1600" b="1" baseline="30000" dirty="0" smtClean="0">
                <a:solidFill>
                  <a:schemeClr val="bg2">
                    <a:lumMod val="25000"/>
                  </a:schemeClr>
                </a:solidFill>
              </a:rPr>
              <a:t>2</a:t>
            </a:r>
            <a:r>
              <a:rPr lang="en-CA" sz="1600" b="1" dirty="0" smtClean="0">
                <a:solidFill>
                  <a:schemeClr val="bg2">
                    <a:lumMod val="25000"/>
                  </a:schemeClr>
                </a:solidFill>
              </a:rPr>
              <a:t> = 0.991 </a:t>
            </a:r>
            <a:endParaRPr lang="en-CA" sz="1600" b="1" dirty="0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17532" y="2864436"/>
            <a:ext cx="12001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b="1" dirty="0" smtClean="0">
                <a:solidFill>
                  <a:schemeClr val="accent1">
                    <a:lumMod val="75000"/>
                  </a:schemeClr>
                </a:solidFill>
              </a:rPr>
              <a:t>R</a:t>
            </a:r>
            <a:r>
              <a:rPr lang="en-CA" sz="1600" b="1" baseline="30000" dirty="0" smtClean="0">
                <a:solidFill>
                  <a:schemeClr val="accent1">
                    <a:lumMod val="75000"/>
                  </a:schemeClr>
                </a:solidFill>
              </a:rPr>
              <a:t>2</a:t>
            </a:r>
            <a:r>
              <a:rPr lang="en-CA" sz="1600" b="1" dirty="0" smtClean="0">
                <a:solidFill>
                  <a:schemeClr val="accent1">
                    <a:lumMod val="75000"/>
                  </a:schemeClr>
                </a:solidFill>
              </a:rPr>
              <a:t> = 0.978 </a:t>
            </a:r>
            <a:endParaRPr lang="en-CA" sz="16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28712" y="3033713"/>
            <a:ext cx="12001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b="1" dirty="0" smtClean="0">
                <a:solidFill>
                  <a:srgbClr val="C00000"/>
                </a:solidFill>
              </a:rPr>
              <a:t>R</a:t>
            </a:r>
            <a:r>
              <a:rPr lang="en-CA" sz="1600" b="1" baseline="30000" dirty="0" smtClean="0">
                <a:solidFill>
                  <a:srgbClr val="C00000"/>
                </a:solidFill>
              </a:rPr>
              <a:t>2</a:t>
            </a:r>
            <a:r>
              <a:rPr lang="en-CA" sz="1600" b="1" dirty="0" smtClean="0">
                <a:solidFill>
                  <a:srgbClr val="C00000"/>
                </a:solidFill>
              </a:rPr>
              <a:t> = 0.929 </a:t>
            </a:r>
            <a:endParaRPr lang="en-CA" sz="16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9942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B91CA220667BD4EA47F712B04FD405A" ma:contentTypeVersion="7" ma:contentTypeDescription="Create a new document." ma:contentTypeScope="" ma:versionID="d6fc86014acda1dc4a20e22ce7ea8260">
  <xsd:schema xmlns:xsd="http://www.w3.org/2001/XMLSchema" xmlns:xs="http://www.w3.org/2001/XMLSchema" xmlns:p="http://schemas.microsoft.com/office/2006/metadata/properties" xmlns:ns3="baee91fb-ddf9-4886-b4bd-68353298e913" xmlns:ns4="c3592ca2-03f1-436a-a907-42f7027c4734" targetNamespace="http://schemas.microsoft.com/office/2006/metadata/properties" ma:root="true" ma:fieldsID="fc76fbd1d1cd3db22f1e2d3bacb209f8" ns3:_="" ns4:_="">
    <xsd:import namespace="baee91fb-ddf9-4886-b4bd-68353298e913"/>
    <xsd:import namespace="c3592ca2-03f1-436a-a907-42f7027c473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aee91fb-ddf9-4886-b4bd-68353298e91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3592ca2-03f1-436a-a907-42f7027c473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F4CB5F1-3038-46C6-84A4-50A59E1139D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aee91fb-ddf9-4886-b4bd-68353298e913"/>
    <ds:schemaRef ds:uri="c3592ca2-03f1-436a-a907-42f7027c473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D6AE3BF-1C4E-4FB3-9860-41B9D34F22B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B7916A4-2557-44B7-A3DD-F2B4EC3F5B2B}">
  <ds:schemaRefs>
    <ds:schemaRef ds:uri="http://purl.org/dc/elements/1.1/"/>
    <ds:schemaRef ds:uri="http://schemas.microsoft.com/office/2006/metadata/properties"/>
    <ds:schemaRef ds:uri="baee91fb-ddf9-4886-b4bd-68353298e913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c3592ca2-03f1-436a-a907-42f7027c4734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750</TotalTime>
  <Words>4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alth Canada - Santé Cana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cker, Michael Glen (PHAC/ASPC)</dc:creator>
  <cp:lastModifiedBy>Becker, Michael Glen (PHAC/ASPC)</cp:lastModifiedBy>
  <cp:revision>12</cp:revision>
  <dcterms:created xsi:type="dcterms:W3CDTF">2022-06-08T18:06:21Z</dcterms:created>
  <dcterms:modified xsi:type="dcterms:W3CDTF">2022-11-30T20:40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B91CA220667BD4EA47F712B04FD405A</vt:lpwstr>
  </property>
</Properties>
</file>